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48"/>
  </p:normalViewPr>
  <p:slideViewPr>
    <p:cSldViewPr snapToGrid="0" showGuides="1">
      <p:cViewPr varScale="1">
        <p:scale>
          <a:sx n="79" d="100"/>
          <a:sy n="79" d="100"/>
        </p:scale>
        <p:origin x="821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80" d="100"/>
        <a:sy n="1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BA55EA-BA60-4765-AFDE-9E16FA32677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0BAD4FD-E65E-4AE0-A47D-177A8BE869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33ECA1-4671-411D-BB38-B301E09EF4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ECD04A-AB6E-496E-A2BB-3AB6DF7DD0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7C3BCD-829E-4C90-B77A-9616766759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70950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5CDC32-3BBB-488A-9C0E-8CE967CB4E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E12241-D4B3-4817-96D5-C3E35F73CC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F8210D-4104-4CB1-B562-06C06603DA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9D055C3-E932-4115-85F0-5B2B424CD5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75620A-0FD4-43CE-8C85-6DE9438753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443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C9B0556-B68F-4A8E-9BE6-662F6F2EF4E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169016-DCDC-4217-87B7-AE206DF2C1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E1FB2A-D48B-4298-B584-B051C2B7A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80866C-ED23-4EB7-88E5-A0BAB13A8E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45A8F9-E7CC-4368-82DC-B636A31AF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7561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67C162-E113-471C-95DB-137DE0B58F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84F1B3-54E8-4A45-A9DC-AC62530B23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2FBCB7-5094-4ADE-BDD6-F97BDA8031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B27FC4-8673-41E3-83AF-E0E5EECFD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F67733-827C-4BA8-8C8B-23EBAC4037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11890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8FE87F-3145-4D09-A4B9-743C473434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B331719-9917-45BF-BCA8-499F47C7BD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5EA4D2-583F-4E11-8642-6A17F8DF2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EA9393-926B-44A8-90E8-4579006443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9F2CF8-6638-4BFA-9B42-AB43BF94C9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6938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14897C-02B0-4085-BBF7-BF56F1F022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EB74D6-365F-4425-81A5-05F2DC6868C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EAD847-2330-4B34-BE1A-B147094CFC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6B54DC-E716-4AB4-B574-99C7AD359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48FA3E-F690-4496-ADED-0544667CBC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D9A8A0-CB73-4F44-A5C0-A6A1D2144E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6608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76BE06-0E67-43DA-B7A0-A1DC19B0DB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8F4AF0-C9CB-4D60-8BF9-4781211A50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EF129C1-7FF7-47DB-8D7B-A48F6A5AF9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D01F605-9827-46A2-93B5-E5B4F33147D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D0EE2F9-6DE0-47BC-AC04-0990AD5AA83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B8DB06E-726A-4F6D-9D45-1D2F4162C7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4B7BD35-5723-4AF2-BD4F-01A828508F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976B483-E08B-48EC-A25C-EFDB8F3C6F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50879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7F61DC-5D53-4F55-B63C-2AC2F902F2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10AF1FC-34DC-43F8-A1B5-F2200E9FB3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2B60EA-0C6E-4A4D-843E-6C342EE1B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B74C134-3934-4DD5-9F71-026F757AF8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3459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44F817B-1CBD-4354-9E53-9CA27687A8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4682F95-4A1A-4586-A8F8-4EA396FE61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BE744A-03C6-43E8-B388-DD37A2C7EB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72260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DDE69-7D92-4188-A360-716A583923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29F4B3-5014-4C78-A419-C9E593F31CC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67A462-1E9A-4CE1-BC8F-47C5599E47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BF2CA5-230D-4C02-8AF2-9ED39A49F0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435F28-FEF1-4365-88C2-A222B903A7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501F4F-3C2C-4910-A0D5-40E5C98C56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2493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EFAA44-D729-4D07-9476-9F5C6B85D4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A19F375-2D5A-4B02-B0D5-41BD43DA2A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277E06-DC49-4ECE-827F-9229AA2AB6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1A09A1-19ED-4759-93C3-AD8EA6EC48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06900B1-7B06-4075-BB30-1C08A3784E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023DE5-3BE7-4CEC-B1CB-E2AF8ED4A5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8395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E9DDC46-FF55-4E43-8ABE-2A0B8E52BB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C38AC6-75C5-499B-BC1F-9E080936D2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815D62-DDDB-43AA-98B2-0C566505FFD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842C6E-735F-44F3-A5C3-E850BB3710A9}" type="datetimeFigureOut">
              <a:rPr lang="en-GB" smtClean="0"/>
              <a:t>21/08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4B81EA-60F6-4064-9D7B-889D8CDCE99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473613-6A02-40F1-AD4C-C5A32198298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E1CAC0-D906-456A-A719-23B477D05B8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1646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6C7298B-634B-461F-BAB8-DA3E96862B8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210" t="12565" r="7183" b="8889"/>
          <a:stretch/>
        </p:blipFill>
        <p:spPr>
          <a:xfrm>
            <a:off x="1905001" y="626533"/>
            <a:ext cx="8593666" cy="463973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38BC3C7-95DF-49F8-AA5B-70424C92C1C1}"/>
              </a:ext>
            </a:extLst>
          </p:cNvPr>
          <p:cNvSpPr txBox="1"/>
          <p:nvPr/>
        </p:nvSpPr>
        <p:spPr>
          <a:xfrm>
            <a:off x="5791199" y="5266267"/>
            <a:ext cx="1507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t(1) (16%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D7A55FB-0C21-41F4-BF6E-50BF93CD6899}"/>
              </a:ext>
            </a:extLst>
          </p:cNvPr>
          <p:cNvSpPr txBox="1"/>
          <p:nvPr/>
        </p:nvSpPr>
        <p:spPr>
          <a:xfrm rot="16200000">
            <a:off x="1000662" y="2880264"/>
            <a:ext cx="1507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t(2) (12%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FEED4FE-B145-4DFD-AB36-B9D1AC00B831}"/>
              </a:ext>
            </a:extLst>
          </p:cNvPr>
          <p:cNvSpPr txBox="1"/>
          <p:nvPr/>
        </p:nvSpPr>
        <p:spPr>
          <a:xfrm>
            <a:off x="10684932" y="762000"/>
            <a:ext cx="150706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 0 months</a:t>
            </a:r>
          </a:p>
          <a:p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 6 months</a:t>
            </a:r>
          </a:p>
          <a:p>
            <a:r>
              <a:rPr lang="en-GB" dirty="0">
                <a:latin typeface="Helvetica" panose="020B0604020202020204" pitchFamily="34" charset="0"/>
                <a:cs typeface="Helvetica" panose="020B0604020202020204" pitchFamily="34" charset="0"/>
              </a:rPr>
              <a:t>12 months</a:t>
            </a:r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30C90426-2132-4E28-A63F-33C4C65806D6}"/>
              </a:ext>
            </a:extLst>
          </p:cNvPr>
          <p:cNvSpPr>
            <a:spLocks noChangeAspect="1"/>
          </p:cNvSpPr>
          <p:nvPr/>
        </p:nvSpPr>
        <p:spPr>
          <a:xfrm>
            <a:off x="10498667" y="1117695"/>
            <a:ext cx="216000" cy="216000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57D186F6-8D44-4734-9023-63655F4FF4F5}"/>
              </a:ext>
            </a:extLst>
          </p:cNvPr>
          <p:cNvSpPr>
            <a:spLocks noChangeAspect="1"/>
          </p:cNvSpPr>
          <p:nvPr/>
        </p:nvSpPr>
        <p:spPr>
          <a:xfrm>
            <a:off x="10498667" y="836707"/>
            <a:ext cx="216000" cy="216000"/>
          </a:xfrm>
          <a:prstGeom prst="ellipse">
            <a:avLst/>
          </a:prstGeom>
          <a:solidFill>
            <a:srgbClr val="00B050"/>
          </a:solidFill>
          <a:ln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AEF4B739-FFCA-4EFA-BE1F-3CF10EC9833A}"/>
              </a:ext>
            </a:extLst>
          </p:cNvPr>
          <p:cNvSpPr>
            <a:spLocks noChangeAspect="1"/>
          </p:cNvSpPr>
          <p:nvPr/>
        </p:nvSpPr>
        <p:spPr>
          <a:xfrm>
            <a:off x="10498667" y="1398683"/>
            <a:ext cx="216000" cy="216000"/>
          </a:xfrm>
          <a:prstGeom prst="ellipse">
            <a:avLst/>
          </a:prstGeom>
          <a:solidFill>
            <a:srgbClr val="FF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D5EDDCF-A069-76A4-ECAB-FF08D1A303F1}"/>
              </a:ext>
            </a:extLst>
          </p:cNvPr>
          <p:cNvSpPr txBox="1"/>
          <p:nvPr/>
        </p:nvSpPr>
        <p:spPr>
          <a:xfrm>
            <a:off x="175986" y="5863399"/>
            <a:ext cx="1091564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l </a:t>
            </a:r>
            <a:r>
              <a:rPr lang="en-GB" b="1"/>
              <a:t>Figure S1</a:t>
            </a:r>
            <a:r>
              <a:rPr lang="en-GB" b="1" dirty="0"/>
              <a:t>: </a:t>
            </a:r>
            <a:r>
              <a:rPr lang="en-GB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CA scores plot depicting the samples for each of the three timepoints. Variables are scaled to unit variance and eclipse represents the 95% Hotelling’s T</a:t>
            </a:r>
            <a:r>
              <a:rPr lang="en-GB" sz="1800" baseline="300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2</a:t>
            </a:r>
            <a:r>
              <a:rPr lang="el-GR" dirty="0">
                <a:effectLst/>
              </a:rPr>
              <a:t>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473210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0</TotalTime>
  <Words>53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orkas, Panagiotis</dc:creator>
  <cp:lastModifiedBy>MDPI</cp:lastModifiedBy>
  <cp:revision>23</cp:revision>
  <dcterms:created xsi:type="dcterms:W3CDTF">2021-12-10T11:16:45Z</dcterms:created>
  <dcterms:modified xsi:type="dcterms:W3CDTF">2023-08-21T13:26:55Z</dcterms:modified>
</cp:coreProperties>
</file>